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>
        <p:scale>
          <a:sx n="80" d="100"/>
          <a:sy n="80" d="100"/>
        </p:scale>
        <p:origin x="552" y="49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4" Type="http://schemas.openxmlformats.org/officeDocument/2006/relationships/image" Target="../media/image4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2843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63917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0695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64789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668488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09386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37682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49402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03841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8344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61027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465B78-4857-42A2-9F3E-68DB90A2B031}" type="datetimeFigureOut">
              <a:rPr lang="en-US" smtClean="0"/>
              <a:t>12/17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B947A8-7AD2-473C-ADBA-F2A33BA796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84570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wmf"/><Relationship Id="rId4" Type="http://schemas.openxmlformats.org/officeDocument/2006/relationships/image" Target="../media/image1.w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6" name="Straight Connector 5"/>
          <p:cNvCxnSpPr/>
          <p:nvPr/>
        </p:nvCxnSpPr>
        <p:spPr>
          <a:xfrm flipV="1">
            <a:off x="1163778" y="1404851"/>
            <a:ext cx="2111434" cy="16626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Connector 6"/>
          <p:cNvCxnSpPr/>
          <p:nvPr/>
        </p:nvCxnSpPr>
        <p:spPr>
          <a:xfrm>
            <a:off x="3394351" y="1415941"/>
            <a:ext cx="2266614" cy="5536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2053244" y="1039089"/>
            <a:ext cx="7441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Saline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245905" y="2241083"/>
            <a:ext cx="6471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KCƐ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3893129" y="1050168"/>
            <a:ext cx="9714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Nicotine</a:t>
            </a:r>
            <a:endParaRPr lang="en-US" dirty="0"/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58526550"/>
              </p:ext>
            </p:extLst>
          </p:nvPr>
        </p:nvGraphicFramePr>
        <p:xfrm>
          <a:off x="1053643" y="1544665"/>
          <a:ext cx="4798518" cy="19280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4" name="Image" r:id="rId3" imgW="4971240" imgH="2133000" progId="Photoshop.Image.13">
                  <p:embed/>
                </p:oleObj>
              </mc:Choice>
              <mc:Fallback>
                <p:oleObj name="Image" r:id="rId3" imgW="4971240" imgH="213300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53643" y="1544665"/>
                        <a:ext cx="4798518" cy="19280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76123692"/>
              </p:ext>
            </p:extLst>
          </p:nvPr>
        </p:nvGraphicFramePr>
        <p:xfrm>
          <a:off x="7348451" y="1465719"/>
          <a:ext cx="3945861" cy="19424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5" name="Image" r:id="rId5" imgW="4028400" imgH="2085480" progId="Photoshop.Image.13">
                  <p:embed/>
                </p:oleObj>
              </mc:Choice>
              <mc:Fallback>
                <p:oleObj name="Image" r:id="rId5" imgW="4028400" imgH="208548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348451" y="1465719"/>
                        <a:ext cx="3945861" cy="19424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5" name="Straight Connector 14"/>
          <p:cNvCxnSpPr/>
          <p:nvPr/>
        </p:nvCxnSpPr>
        <p:spPr>
          <a:xfrm flipV="1">
            <a:off x="7348451" y="1338349"/>
            <a:ext cx="1770611" cy="8313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/>
          <p:cNvCxnSpPr/>
          <p:nvPr/>
        </p:nvCxnSpPr>
        <p:spPr>
          <a:xfrm flipV="1">
            <a:off x="9462653" y="1341122"/>
            <a:ext cx="1770611" cy="8313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7633841" y="991978"/>
            <a:ext cx="12634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Saline+NAC</a:t>
            </a:r>
            <a:endParaRPr 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9573481" y="994751"/>
            <a:ext cx="14907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Nicotine+NAC</a:t>
            </a:r>
            <a:endParaRPr lang="en-US" dirty="0"/>
          </a:p>
        </p:txBody>
      </p:sp>
      <p:sp>
        <p:nvSpPr>
          <p:cNvPr id="21" name="TextBox 20"/>
          <p:cNvSpPr txBox="1"/>
          <p:nvPr/>
        </p:nvSpPr>
        <p:spPr>
          <a:xfrm>
            <a:off x="6466585" y="2235544"/>
            <a:ext cx="6471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PKCƐ</a:t>
            </a:r>
            <a:endParaRPr lang="en-US" dirty="0"/>
          </a:p>
        </p:txBody>
      </p:sp>
      <p:graphicFrame>
        <p:nvGraphicFramePr>
          <p:cNvPr id="22" name="Object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87227766"/>
              </p:ext>
            </p:extLst>
          </p:nvPr>
        </p:nvGraphicFramePr>
        <p:xfrm>
          <a:off x="1053644" y="4181302"/>
          <a:ext cx="4798518" cy="193406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6" name="Image" r:id="rId7" imgW="5037840" imgH="2266560" progId="Photoshop.Image.13">
                  <p:embed/>
                </p:oleObj>
              </mc:Choice>
              <mc:Fallback>
                <p:oleObj name="Image" r:id="rId7" imgW="5037840" imgH="226656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053644" y="4181302"/>
                        <a:ext cx="4798518" cy="193406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24" name="Straight Connector 23"/>
          <p:cNvCxnSpPr/>
          <p:nvPr/>
        </p:nvCxnSpPr>
        <p:spPr>
          <a:xfrm>
            <a:off x="3327031" y="1050168"/>
            <a:ext cx="25755" cy="5392196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82417" y="4795858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ADPH</a:t>
            </a:r>
            <a:endParaRPr lang="en-US" dirty="0"/>
          </a:p>
        </p:txBody>
      </p:sp>
      <p:cxnSp>
        <p:nvCxnSpPr>
          <p:cNvPr id="28" name="Straight Arrow Connector 27"/>
          <p:cNvCxnSpPr>
            <a:stCxn id="10" idx="3"/>
          </p:cNvCxnSpPr>
          <p:nvPr/>
        </p:nvCxnSpPr>
        <p:spPr>
          <a:xfrm>
            <a:off x="893070" y="2425749"/>
            <a:ext cx="270708" cy="1567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/>
          <p:cNvCxnSpPr/>
          <p:nvPr/>
        </p:nvCxnSpPr>
        <p:spPr>
          <a:xfrm>
            <a:off x="887532" y="4988835"/>
            <a:ext cx="270708" cy="1567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/>
          <p:nvPr/>
        </p:nvCxnSpPr>
        <p:spPr>
          <a:xfrm>
            <a:off x="7030621" y="2420207"/>
            <a:ext cx="270708" cy="1567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32" name="Object 3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18422399"/>
              </p:ext>
            </p:extLst>
          </p:nvPr>
        </p:nvGraphicFramePr>
        <p:xfrm>
          <a:off x="7348451" y="4181302"/>
          <a:ext cx="4014874" cy="1866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7" name="Image" r:id="rId9" imgW="5742720" imgH="2409480" progId="Photoshop.Image.13">
                  <p:embed/>
                </p:oleObj>
              </mc:Choice>
              <mc:Fallback>
                <p:oleObj name="Image" r:id="rId9" imgW="5742720" imgH="240948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7348451" y="4181302"/>
                        <a:ext cx="4014874" cy="1866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3" name="TextBox 32"/>
          <p:cNvSpPr txBox="1"/>
          <p:nvPr/>
        </p:nvSpPr>
        <p:spPr>
          <a:xfrm>
            <a:off x="6292717" y="5062558"/>
            <a:ext cx="869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GADPH</a:t>
            </a:r>
            <a:endParaRPr lang="en-US" dirty="0"/>
          </a:p>
        </p:txBody>
      </p:sp>
      <p:cxnSp>
        <p:nvCxnSpPr>
          <p:cNvPr id="34" name="Straight Arrow Connector 33"/>
          <p:cNvCxnSpPr/>
          <p:nvPr/>
        </p:nvCxnSpPr>
        <p:spPr>
          <a:xfrm>
            <a:off x="7097832" y="5226960"/>
            <a:ext cx="270708" cy="1567"/>
          </a:xfrm>
          <a:prstGeom prst="straightConnector1">
            <a:avLst/>
          </a:prstGeom>
          <a:ln w="3810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/>
          <p:cNvCxnSpPr/>
          <p:nvPr/>
        </p:nvCxnSpPr>
        <p:spPr>
          <a:xfrm>
            <a:off x="9308503" y="1039089"/>
            <a:ext cx="25755" cy="5392196"/>
          </a:xfrm>
          <a:prstGeom prst="line">
            <a:avLst/>
          </a:prstGeom>
          <a:ln w="3810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1136116" y="66675"/>
            <a:ext cx="934582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 smtClean="0">
                <a:latin typeface="Arial" panose="020B0604020202020204" pitchFamily="34" charset="0"/>
                <a:cs typeface="Arial" panose="020B0604020202020204" pitchFamily="34" charset="0"/>
              </a:rPr>
              <a:t>The original blot images which we generated for Figure 5.</a:t>
            </a:r>
            <a:endParaRPr 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33028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4</TotalTime>
  <Words>19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Adobe Photoshop Image</vt:lpstr>
      <vt:lpstr>PowerPoint Presentation</vt:lpstr>
    </vt:vector>
  </TitlesOfParts>
  <Company>Loma Linda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Xiao, Daliao (LLU)</dc:creator>
  <cp:lastModifiedBy>Xiao, Daliao (LLU)</cp:lastModifiedBy>
  <cp:revision>7</cp:revision>
  <dcterms:created xsi:type="dcterms:W3CDTF">2015-12-16T17:26:50Z</dcterms:created>
  <dcterms:modified xsi:type="dcterms:W3CDTF">2015-12-17T19:06:39Z</dcterms:modified>
</cp:coreProperties>
</file>